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</p:sldIdLst>
  <p:sldSz cx="21031200" cy="146304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08" userDrawn="1">
          <p15:clr>
            <a:srgbClr val="A4A3A4"/>
          </p15:clr>
        </p15:guide>
        <p15:guide id="2" pos="66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0" autoAdjust="0"/>
    <p:restoredTop sz="94660"/>
  </p:normalViewPr>
  <p:slideViewPr>
    <p:cSldViewPr snapToGrid="0" showGuides="1">
      <p:cViewPr varScale="1">
        <p:scale>
          <a:sx n="44" d="100"/>
          <a:sy n="44" d="100"/>
        </p:scale>
        <p:origin x="1432" y="224"/>
      </p:cViewPr>
      <p:guideLst>
        <p:guide orient="horz" pos="4608"/>
        <p:guide pos="66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77340" y="2394374"/>
            <a:ext cx="17876520" cy="5093547"/>
          </a:xfrm>
        </p:spPr>
        <p:txBody>
          <a:bodyPr anchor="b"/>
          <a:lstStyle>
            <a:lvl1pPr algn="ctr">
              <a:defRPr sz="12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28900" y="7684348"/>
            <a:ext cx="15773400" cy="3532292"/>
          </a:xfrm>
        </p:spPr>
        <p:txBody>
          <a:bodyPr/>
          <a:lstStyle>
            <a:lvl1pPr marL="0" indent="0" algn="ctr">
              <a:buNone/>
              <a:defRPr sz="5120"/>
            </a:lvl1pPr>
            <a:lvl2pPr marL="975345" indent="0" algn="ctr">
              <a:buNone/>
              <a:defRPr sz="4267"/>
            </a:lvl2pPr>
            <a:lvl3pPr marL="1950690" indent="0" algn="ctr">
              <a:buNone/>
              <a:defRPr sz="3840"/>
            </a:lvl3pPr>
            <a:lvl4pPr marL="2926034" indent="0" algn="ctr">
              <a:buNone/>
              <a:defRPr sz="3413"/>
            </a:lvl4pPr>
            <a:lvl5pPr marL="3901379" indent="0" algn="ctr">
              <a:buNone/>
              <a:defRPr sz="3413"/>
            </a:lvl5pPr>
            <a:lvl6pPr marL="4876724" indent="0" algn="ctr">
              <a:buNone/>
              <a:defRPr sz="3413"/>
            </a:lvl6pPr>
            <a:lvl7pPr marL="5852069" indent="0" algn="ctr">
              <a:buNone/>
              <a:defRPr sz="3413"/>
            </a:lvl7pPr>
            <a:lvl8pPr marL="6827413" indent="0" algn="ctr">
              <a:buNone/>
              <a:defRPr sz="3413"/>
            </a:lvl8pPr>
            <a:lvl9pPr marL="7802758" indent="0" algn="ctr">
              <a:buNone/>
              <a:defRPr sz="341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159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702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050453" y="778933"/>
            <a:ext cx="4534853" cy="123985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45896" y="778933"/>
            <a:ext cx="13341668" cy="1239858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977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058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34942" y="3647444"/>
            <a:ext cx="18139410" cy="6085839"/>
          </a:xfrm>
        </p:spPr>
        <p:txBody>
          <a:bodyPr anchor="b"/>
          <a:lstStyle>
            <a:lvl1pPr>
              <a:defRPr sz="12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34942" y="9790858"/>
            <a:ext cx="18139410" cy="3200399"/>
          </a:xfrm>
        </p:spPr>
        <p:txBody>
          <a:bodyPr/>
          <a:lstStyle>
            <a:lvl1pPr marL="0" indent="0">
              <a:buNone/>
              <a:defRPr sz="5120">
                <a:solidFill>
                  <a:schemeClr val="tx1"/>
                </a:solidFill>
              </a:defRPr>
            </a:lvl1pPr>
            <a:lvl2pPr marL="975345" indent="0">
              <a:buNone/>
              <a:defRPr sz="4267">
                <a:solidFill>
                  <a:schemeClr val="tx1">
                    <a:tint val="75000"/>
                  </a:schemeClr>
                </a:solidFill>
              </a:defRPr>
            </a:lvl2pPr>
            <a:lvl3pPr marL="1950690" indent="0">
              <a:buNone/>
              <a:defRPr sz="3840">
                <a:solidFill>
                  <a:schemeClr val="tx1">
                    <a:tint val="75000"/>
                  </a:schemeClr>
                </a:solidFill>
              </a:defRPr>
            </a:lvl3pPr>
            <a:lvl4pPr marL="2926034" indent="0">
              <a:buNone/>
              <a:defRPr sz="3413">
                <a:solidFill>
                  <a:schemeClr val="tx1">
                    <a:tint val="75000"/>
                  </a:schemeClr>
                </a:solidFill>
              </a:defRPr>
            </a:lvl4pPr>
            <a:lvl5pPr marL="3901379" indent="0">
              <a:buNone/>
              <a:defRPr sz="3413">
                <a:solidFill>
                  <a:schemeClr val="tx1">
                    <a:tint val="75000"/>
                  </a:schemeClr>
                </a:solidFill>
              </a:defRPr>
            </a:lvl5pPr>
            <a:lvl6pPr marL="4876724" indent="0">
              <a:buNone/>
              <a:defRPr sz="3413">
                <a:solidFill>
                  <a:schemeClr val="tx1">
                    <a:tint val="75000"/>
                  </a:schemeClr>
                </a:solidFill>
              </a:defRPr>
            </a:lvl6pPr>
            <a:lvl7pPr marL="5852069" indent="0">
              <a:buNone/>
              <a:defRPr sz="3413">
                <a:solidFill>
                  <a:schemeClr val="tx1">
                    <a:tint val="75000"/>
                  </a:schemeClr>
                </a:solidFill>
              </a:defRPr>
            </a:lvl7pPr>
            <a:lvl8pPr marL="6827413" indent="0">
              <a:buNone/>
              <a:defRPr sz="3413">
                <a:solidFill>
                  <a:schemeClr val="tx1">
                    <a:tint val="75000"/>
                  </a:schemeClr>
                </a:solidFill>
              </a:defRPr>
            </a:lvl8pPr>
            <a:lvl9pPr marL="7802758" indent="0">
              <a:buNone/>
              <a:defRPr sz="341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570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45895" y="3894667"/>
            <a:ext cx="8938260" cy="9282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647045" y="3894667"/>
            <a:ext cx="8938260" cy="92828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823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8634" y="778936"/>
            <a:ext cx="18139410" cy="282786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8637" y="3586481"/>
            <a:ext cx="8897182" cy="1757679"/>
          </a:xfrm>
        </p:spPr>
        <p:txBody>
          <a:bodyPr anchor="b"/>
          <a:lstStyle>
            <a:lvl1pPr marL="0" indent="0">
              <a:buNone/>
              <a:defRPr sz="5120" b="1"/>
            </a:lvl1pPr>
            <a:lvl2pPr marL="975345" indent="0">
              <a:buNone/>
              <a:defRPr sz="4267" b="1"/>
            </a:lvl2pPr>
            <a:lvl3pPr marL="1950690" indent="0">
              <a:buNone/>
              <a:defRPr sz="3840" b="1"/>
            </a:lvl3pPr>
            <a:lvl4pPr marL="2926034" indent="0">
              <a:buNone/>
              <a:defRPr sz="3413" b="1"/>
            </a:lvl4pPr>
            <a:lvl5pPr marL="3901379" indent="0">
              <a:buNone/>
              <a:defRPr sz="3413" b="1"/>
            </a:lvl5pPr>
            <a:lvl6pPr marL="4876724" indent="0">
              <a:buNone/>
              <a:defRPr sz="3413" b="1"/>
            </a:lvl6pPr>
            <a:lvl7pPr marL="5852069" indent="0">
              <a:buNone/>
              <a:defRPr sz="3413" b="1"/>
            </a:lvl7pPr>
            <a:lvl8pPr marL="6827413" indent="0">
              <a:buNone/>
              <a:defRPr sz="3413" b="1"/>
            </a:lvl8pPr>
            <a:lvl9pPr marL="7802758" indent="0">
              <a:buNone/>
              <a:defRPr sz="341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48637" y="5344160"/>
            <a:ext cx="8897182" cy="78604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647046" y="3586481"/>
            <a:ext cx="8940999" cy="1757679"/>
          </a:xfrm>
        </p:spPr>
        <p:txBody>
          <a:bodyPr anchor="b"/>
          <a:lstStyle>
            <a:lvl1pPr marL="0" indent="0">
              <a:buNone/>
              <a:defRPr sz="5120" b="1"/>
            </a:lvl1pPr>
            <a:lvl2pPr marL="975345" indent="0">
              <a:buNone/>
              <a:defRPr sz="4267" b="1"/>
            </a:lvl2pPr>
            <a:lvl3pPr marL="1950690" indent="0">
              <a:buNone/>
              <a:defRPr sz="3840" b="1"/>
            </a:lvl3pPr>
            <a:lvl4pPr marL="2926034" indent="0">
              <a:buNone/>
              <a:defRPr sz="3413" b="1"/>
            </a:lvl4pPr>
            <a:lvl5pPr marL="3901379" indent="0">
              <a:buNone/>
              <a:defRPr sz="3413" b="1"/>
            </a:lvl5pPr>
            <a:lvl6pPr marL="4876724" indent="0">
              <a:buNone/>
              <a:defRPr sz="3413" b="1"/>
            </a:lvl6pPr>
            <a:lvl7pPr marL="5852069" indent="0">
              <a:buNone/>
              <a:defRPr sz="3413" b="1"/>
            </a:lvl7pPr>
            <a:lvl8pPr marL="6827413" indent="0">
              <a:buNone/>
              <a:defRPr sz="3413" b="1"/>
            </a:lvl8pPr>
            <a:lvl9pPr marL="7802758" indent="0">
              <a:buNone/>
              <a:defRPr sz="341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647046" y="5344160"/>
            <a:ext cx="8940999" cy="786045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599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3886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2329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8635" y="975360"/>
            <a:ext cx="6783109" cy="3413760"/>
          </a:xfrm>
        </p:spPr>
        <p:txBody>
          <a:bodyPr anchor="b"/>
          <a:lstStyle>
            <a:lvl1pPr>
              <a:defRPr sz="68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940999" y="2106510"/>
            <a:ext cx="10647045" cy="10397067"/>
          </a:xfrm>
        </p:spPr>
        <p:txBody>
          <a:bodyPr/>
          <a:lstStyle>
            <a:lvl1pPr>
              <a:defRPr sz="6827"/>
            </a:lvl1pPr>
            <a:lvl2pPr>
              <a:defRPr sz="5973"/>
            </a:lvl2pPr>
            <a:lvl3pPr>
              <a:defRPr sz="5120"/>
            </a:lvl3pPr>
            <a:lvl4pPr>
              <a:defRPr sz="4267"/>
            </a:lvl4pPr>
            <a:lvl5pPr>
              <a:defRPr sz="4267"/>
            </a:lvl5pPr>
            <a:lvl6pPr>
              <a:defRPr sz="4267"/>
            </a:lvl6pPr>
            <a:lvl7pPr>
              <a:defRPr sz="4267"/>
            </a:lvl7pPr>
            <a:lvl8pPr>
              <a:defRPr sz="4267"/>
            </a:lvl8pPr>
            <a:lvl9pPr>
              <a:defRPr sz="42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48635" y="4389120"/>
            <a:ext cx="6783109" cy="8131388"/>
          </a:xfrm>
        </p:spPr>
        <p:txBody>
          <a:bodyPr/>
          <a:lstStyle>
            <a:lvl1pPr marL="0" indent="0">
              <a:buNone/>
              <a:defRPr sz="3413"/>
            </a:lvl1pPr>
            <a:lvl2pPr marL="975345" indent="0">
              <a:buNone/>
              <a:defRPr sz="2987"/>
            </a:lvl2pPr>
            <a:lvl3pPr marL="1950690" indent="0">
              <a:buNone/>
              <a:defRPr sz="2560"/>
            </a:lvl3pPr>
            <a:lvl4pPr marL="2926034" indent="0">
              <a:buNone/>
              <a:defRPr sz="2133"/>
            </a:lvl4pPr>
            <a:lvl5pPr marL="3901379" indent="0">
              <a:buNone/>
              <a:defRPr sz="2133"/>
            </a:lvl5pPr>
            <a:lvl6pPr marL="4876724" indent="0">
              <a:buNone/>
              <a:defRPr sz="2133"/>
            </a:lvl6pPr>
            <a:lvl7pPr marL="5852069" indent="0">
              <a:buNone/>
              <a:defRPr sz="2133"/>
            </a:lvl7pPr>
            <a:lvl8pPr marL="6827413" indent="0">
              <a:buNone/>
              <a:defRPr sz="2133"/>
            </a:lvl8pPr>
            <a:lvl9pPr marL="7802758" indent="0">
              <a:buNone/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131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8635" y="975360"/>
            <a:ext cx="6783109" cy="3413760"/>
          </a:xfrm>
        </p:spPr>
        <p:txBody>
          <a:bodyPr anchor="b"/>
          <a:lstStyle>
            <a:lvl1pPr>
              <a:defRPr sz="68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940999" y="2106510"/>
            <a:ext cx="10647045" cy="10397067"/>
          </a:xfrm>
        </p:spPr>
        <p:txBody>
          <a:bodyPr anchor="t"/>
          <a:lstStyle>
            <a:lvl1pPr marL="0" indent="0">
              <a:buNone/>
              <a:defRPr sz="6827"/>
            </a:lvl1pPr>
            <a:lvl2pPr marL="975345" indent="0">
              <a:buNone/>
              <a:defRPr sz="5973"/>
            </a:lvl2pPr>
            <a:lvl3pPr marL="1950690" indent="0">
              <a:buNone/>
              <a:defRPr sz="5120"/>
            </a:lvl3pPr>
            <a:lvl4pPr marL="2926034" indent="0">
              <a:buNone/>
              <a:defRPr sz="4267"/>
            </a:lvl4pPr>
            <a:lvl5pPr marL="3901379" indent="0">
              <a:buNone/>
              <a:defRPr sz="4267"/>
            </a:lvl5pPr>
            <a:lvl6pPr marL="4876724" indent="0">
              <a:buNone/>
              <a:defRPr sz="4267"/>
            </a:lvl6pPr>
            <a:lvl7pPr marL="5852069" indent="0">
              <a:buNone/>
              <a:defRPr sz="4267"/>
            </a:lvl7pPr>
            <a:lvl8pPr marL="6827413" indent="0">
              <a:buNone/>
              <a:defRPr sz="4267"/>
            </a:lvl8pPr>
            <a:lvl9pPr marL="7802758" indent="0">
              <a:buNone/>
              <a:defRPr sz="42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48635" y="4389120"/>
            <a:ext cx="6783109" cy="8131388"/>
          </a:xfrm>
        </p:spPr>
        <p:txBody>
          <a:bodyPr/>
          <a:lstStyle>
            <a:lvl1pPr marL="0" indent="0">
              <a:buNone/>
              <a:defRPr sz="3413"/>
            </a:lvl1pPr>
            <a:lvl2pPr marL="975345" indent="0">
              <a:buNone/>
              <a:defRPr sz="2987"/>
            </a:lvl2pPr>
            <a:lvl3pPr marL="1950690" indent="0">
              <a:buNone/>
              <a:defRPr sz="2560"/>
            </a:lvl3pPr>
            <a:lvl4pPr marL="2926034" indent="0">
              <a:buNone/>
              <a:defRPr sz="2133"/>
            </a:lvl4pPr>
            <a:lvl5pPr marL="3901379" indent="0">
              <a:buNone/>
              <a:defRPr sz="2133"/>
            </a:lvl5pPr>
            <a:lvl6pPr marL="4876724" indent="0">
              <a:buNone/>
              <a:defRPr sz="2133"/>
            </a:lvl6pPr>
            <a:lvl7pPr marL="5852069" indent="0">
              <a:buNone/>
              <a:defRPr sz="2133"/>
            </a:lvl7pPr>
            <a:lvl8pPr marL="6827413" indent="0">
              <a:buNone/>
              <a:defRPr sz="2133"/>
            </a:lvl8pPr>
            <a:lvl9pPr marL="7802758" indent="0">
              <a:buNone/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125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45895" y="778936"/>
            <a:ext cx="18139410" cy="28278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5895" y="3894667"/>
            <a:ext cx="18139410" cy="92828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45895" y="13560217"/>
            <a:ext cx="473202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06443B-932D-44D5-8275-7C1FA3897FE9}" type="datetimeFigureOut">
              <a:rPr lang="en-US" smtClean="0"/>
              <a:t>9/2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966585" y="13560217"/>
            <a:ext cx="709803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4853285" y="13560217"/>
            <a:ext cx="473202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5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BE2B73-4B95-49BD-8DA8-1E7D79A615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763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950690" rtl="0" eaLnBrk="1" latinLnBrk="0" hangingPunct="1">
        <a:lnSpc>
          <a:spcPct val="90000"/>
        </a:lnSpc>
        <a:spcBef>
          <a:spcPct val="0"/>
        </a:spcBef>
        <a:buNone/>
        <a:defRPr sz="93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7672" indent="-487672" algn="l" defTabSz="1950690" rtl="0" eaLnBrk="1" latinLnBrk="0" hangingPunct="1">
        <a:lnSpc>
          <a:spcPct val="90000"/>
        </a:lnSpc>
        <a:spcBef>
          <a:spcPts val="2133"/>
        </a:spcBef>
        <a:buFont typeface="Arial" panose="020B0604020202020204" pitchFamily="34" charset="0"/>
        <a:buChar char="•"/>
        <a:defRPr sz="5973" kern="1200">
          <a:solidFill>
            <a:schemeClr val="tx1"/>
          </a:solidFill>
          <a:latin typeface="+mn-lt"/>
          <a:ea typeface="+mn-ea"/>
          <a:cs typeface="+mn-cs"/>
        </a:defRPr>
      </a:lvl1pPr>
      <a:lvl2pPr marL="1463017" indent="-487672" algn="l" defTabSz="1950690" rtl="0" eaLnBrk="1" latinLnBrk="0" hangingPunct="1">
        <a:lnSpc>
          <a:spcPct val="90000"/>
        </a:lnSpc>
        <a:spcBef>
          <a:spcPts val="1067"/>
        </a:spcBef>
        <a:buFont typeface="Arial" panose="020B0604020202020204" pitchFamily="34" charset="0"/>
        <a:buChar char="•"/>
        <a:defRPr sz="5120" kern="1200">
          <a:solidFill>
            <a:schemeClr val="tx1"/>
          </a:solidFill>
          <a:latin typeface="+mn-lt"/>
          <a:ea typeface="+mn-ea"/>
          <a:cs typeface="+mn-cs"/>
        </a:defRPr>
      </a:lvl2pPr>
      <a:lvl3pPr marL="2438362" indent="-487672" algn="l" defTabSz="1950690" rtl="0" eaLnBrk="1" latinLnBrk="0" hangingPunct="1">
        <a:lnSpc>
          <a:spcPct val="90000"/>
        </a:lnSpc>
        <a:spcBef>
          <a:spcPts val="1067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3413707" indent="-487672" algn="l" defTabSz="1950690" rtl="0" eaLnBrk="1" latinLnBrk="0" hangingPunct="1">
        <a:lnSpc>
          <a:spcPct val="90000"/>
        </a:lnSpc>
        <a:spcBef>
          <a:spcPts val="1067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4pPr>
      <a:lvl5pPr marL="4389051" indent="-487672" algn="l" defTabSz="1950690" rtl="0" eaLnBrk="1" latinLnBrk="0" hangingPunct="1">
        <a:lnSpc>
          <a:spcPct val="90000"/>
        </a:lnSpc>
        <a:spcBef>
          <a:spcPts val="1067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5pPr>
      <a:lvl6pPr marL="5364396" indent="-487672" algn="l" defTabSz="1950690" rtl="0" eaLnBrk="1" latinLnBrk="0" hangingPunct="1">
        <a:lnSpc>
          <a:spcPct val="90000"/>
        </a:lnSpc>
        <a:spcBef>
          <a:spcPts val="1067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6pPr>
      <a:lvl7pPr marL="6339741" indent="-487672" algn="l" defTabSz="1950690" rtl="0" eaLnBrk="1" latinLnBrk="0" hangingPunct="1">
        <a:lnSpc>
          <a:spcPct val="90000"/>
        </a:lnSpc>
        <a:spcBef>
          <a:spcPts val="1067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7pPr>
      <a:lvl8pPr marL="7315086" indent="-487672" algn="l" defTabSz="1950690" rtl="0" eaLnBrk="1" latinLnBrk="0" hangingPunct="1">
        <a:lnSpc>
          <a:spcPct val="90000"/>
        </a:lnSpc>
        <a:spcBef>
          <a:spcPts val="1067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8pPr>
      <a:lvl9pPr marL="8290430" indent="-487672" algn="l" defTabSz="1950690" rtl="0" eaLnBrk="1" latinLnBrk="0" hangingPunct="1">
        <a:lnSpc>
          <a:spcPct val="90000"/>
        </a:lnSpc>
        <a:spcBef>
          <a:spcPts val="1067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50690" rtl="0" eaLnBrk="1" latinLnBrk="0" hangingPunct="1">
        <a:defRPr sz="3840" kern="1200">
          <a:solidFill>
            <a:schemeClr val="tx1"/>
          </a:solidFill>
          <a:latin typeface="+mn-lt"/>
          <a:ea typeface="+mn-ea"/>
          <a:cs typeface="+mn-cs"/>
        </a:defRPr>
      </a:lvl1pPr>
      <a:lvl2pPr marL="975345" algn="l" defTabSz="1950690" rtl="0" eaLnBrk="1" latinLnBrk="0" hangingPunct="1">
        <a:defRPr sz="3840" kern="1200">
          <a:solidFill>
            <a:schemeClr val="tx1"/>
          </a:solidFill>
          <a:latin typeface="+mn-lt"/>
          <a:ea typeface="+mn-ea"/>
          <a:cs typeface="+mn-cs"/>
        </a:defRPr>
      </a:lvl2pPr>
      <a:lvl3pPr marL="1950690" algn="l" defTabSz="1950690" rtl="0" eaLnBrk="1" latinLnBrk="0" hangingPunct="1">
        <a:defRPr sz="3840" kern="1200">
          <a:solidFill>
            <a:schemeClr val="tx1"/>
          </a:solidFill>
          <a:latin typeface="+mn-lt"/>
          <a:ea typeface="+mn-ea"/>
          <a:cs typeface="+mn-cs"/>
        </a:defRPr>
      </a:lvl3pPr>
      <a:lvl4pPr marL="2926034" algn="l" defTabSz="1950690" rtl="0" eaLnBrk="1" latinLnBrk="0" hangingPunct="1">
        <a:defRPr sz="3840" kern="1200">
          <a:solidFill>
            <a:schemeClr val="tx1"/>
          </a:solidFill>
          <a:latin typeface="+mn-lt"/>
          <a:ea typeface="+mn-ea"/>
          <a:cs typeface="+mn-cs"/>
        </a:defRPr>
      </a:lvl4pPr>
      <a:lvl5pPr marL="3901379" algn="l" defTabSz="1950690" rtl="0" eaLnBrk="1" latinLnBrk="0" hangingPunct="1">
        <a:defRPr sz="3840" kern="1200">
          <a:solidFill>
            <a:schemeClr val="tx1"/>
          </a:solidFill>
          <a:latin typeface="+mn-lt"/>
          <a:ea typeface="+mn-ea"/>
          <a:cs typeface="+mn-cs"/>
        </a:defRPr>
      </a:lvl5pPr>
      <a:lvl6pPr marL="4876724" algn="l" defTabSz="1950690" rtl="0" eaLnBrk="1" latinLnBrk="0" hangingPunct="1">
        <a:defRPr sz="3840" kern="1200">
          <a:solidFill>
            <a:schemeClr val="tx1"/>
          </a:solidFill>
          <a:latin typeface="+mn-lt"/>
          <a:ea typeface="+mn-ea"/>
          <a:cs typeface="+mn-cs"/>
        </a:defRPr>
      </a:lvl6pPr>
      <a:lvl7pPr marL="5852069" algn="l" defTabSz="1950690" rtl="0" eaLnBrk="1" latinLnBrk="0" hangingPunct="1">
        <a:defRPr sz="3840" kern="1200">
          <a:solidFill>
            <a:schemeClr val="tx1"/>
          </a:solidFill>
          <a:latin typeface="+mn-lt"/>
          <a:ea typeface="+mn-ea"/>
          <a:cs typeface="+mn-cs"/>
        </a:defRPr>
      </a:lvl7pPr>
      <a:lvl8pPr marL="6827413" algn="l" defTabSz="1950690" rtl="0" eaLnBrk="1" latinLnBrk="0" hangingPunct="1">
        <a:defRPr sz="3840" kern="1200">
          <a:solidFill>
            <a:schemeClr val="tx1"/>
          </a:solidFill>
          <a:latin typeface="+mn-lt"/>
          <a:ea typeface="+mn-ea"/>
          <a:cs typeface="+mn-cs"/>
        </a:defRPr>
      </a:lvl8pPr>
      <a:lvl9pPr marL="7802758" algn="l" defTabSz="1950690" rtl="0" eaLnBrk="1" latinLnBrk="0" hangingPunct="1">
        <a:defRPr sz="38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48CC3DC-05D6-BE57-110D-0F6261F62D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9323" y="756326"/>
            <a:ext cx="9806940" cy="6858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86F1C37-E8AC-3CC0-DABA-9948DD6712E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36262" y="756326"/>
            <a:ext cx="8322468" cy="6858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B7B2CF8-E5B7-F511-1C0A-F4907262C28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9322" y="7614326"/>
            <a:ext cx="9806939" cy="625974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6B7A2EE-41C3-FAF1-4520-2D51294500B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36262" y="7614326"/>
            <a:ext cx="8322468" cy="625974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B42E8DF-025D-183A-D0AF-E23062C951E9}"/>
              </a:ext>
            </a:extLst>
          </p:cNvPr>
          <p:cNvSpPr txBox="1"/>
          <p:nvPr/>
        </p:nvSpPr>
        <p:spPr>
          <a:xfrm rot="16200000">
            <a:off x="841790" y="3451122"/>
            <a:ext cx="19287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CvsJMF</a:t>
            </a:r>
            <a:endParaRPr 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3A23917-63E8-CB0F-86F5-7C849536594C}"/>
              </a:ext>
            </a:extLst>
          </p:cNvPr>
          <p:cNvSpPr txBox="1"/>
          <p:nvPr/>
        </p:nvSpPr>
        <p:spPr>
          <a:xfrm rot="16200000">
            <a:off x="880262" y="10166832"/>
            <a:ext cx="18517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CvsJHF</a:t>
            </a:r>
            <a:endParaRPr 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0C19D2E-90D5-68AF-E986-83008B5A4CB6}"/>
              </a:ext>
            </a:extLst>
          </p:cNvPr>
          <p:cNvSpPr txBox="1"/>
          <p:nvPr/>
        </p:nvSpPr>
        <p:spPr>
          <a:xfrm>
            <a:off x="447869" y="317241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7046263C-8FB2-9753-775B-B71401EA8BB4}"/>
              </a:ext>
            </a:extLst>
          </p:cNvPr>
          <p:cNvSpPr txBox="1"/>
          <p:nvPr/>
        </p:nvSpPr>
        <p:spPr>
          <a:xfrm>
            <a:off x="825847" y="51768"/>
            <a:ext cx="202938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a</a:t>
            </a:r>
            <a:r>
              <a:rPr lang="en-GB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Scatter plots of pathways to which the DAMs were enriched and Top- and bottom DAMs in </a:t>
            </a:r>
            <a:r>
              <a:rPr lang="en-GB" sz="18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CvsJMF</a:t>
            </a:r>
            <a:r>
              <a:rPr lang="en-GB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8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CvsJHF</a:t>
            </a:r>
            <a:r>
              <a:rPr lang="en-GB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8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Scatter plots of pathways to which the DAMs were enriched and Top- and bottom DAMs in </a:t>
            </a:r>
            <a:r>
              <a:rPr lang="en-GB" sz="18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vsGMF</a:t>
            </a:r>
            <a:r>
              <a:rPr lang="en-GB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8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vsGHF</a:t>
            </a:r>
            <a:r>
              <a:rPr lang="en-GB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Scatter plots of pathways to which the DAMs were enriched and Top- and bottom DAMs in </a:t>
            </a:r>
            <a:r>
              <a:rPr lang="en-GB" sz="18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vsTMF</a:t>
            </a:r>
            <a:r>
              <a:rPr lang="en-GB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8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vsTHF</a:t>
            </a:r>
            <a:r>
              <a:rPr lang="en-GB" sz="18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7268423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5115F982-9D9A-72B6-5DE9-CC9806F2FA01}"/>
              </a:ext>
            </a:extLst>
          </p:cNvPr>
          <p:cNvGrpSpPr/>
          <p:nvPr/>
        </p:nvGrpSpPr>
        <p:grpSpPr>
          <a:xfrm>
            <a:off x="1697268" y="333601"/>
            <a:ext cx="18875525" cy="13963198"/>
            <a:chOff x="1077837" y="333601"/>
            <a:chExt cx="18875525" cy="1396319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94C56BF-D2CD-1E30-D3C3-9420680A36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7837" y="333601"/>
              <a:ext cx="9806940" cy="7315834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8505E28-D4E7-72CC-FF23-E0720298F6D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84777" y="333601"/>
              <a:ext cx="8878069" cy="731583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FAFB69D-0DE9-252D-4F05-8F67D1C8E01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77838" y="6980965"/>
              <a:ext cx="9806940" cy="731520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46AAA24E-D457-3A57-DCF0-23C5ED07A27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84776" y="6980965"/>
              <a:ext cx="9068586" cy="7315834"/>
            </a:xfrm>
            <a:prstGeom prst="rect">
              <a:avLst/>
            </a:prstGeom>
          </p:spPr>
        </p:pic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BA489A9F-1405-F039-0071-62F17A935BC8}"/>
              </a:ext>
            </a:extLst>
          </p:cNvPr>
          <p:cNvSpPr txBox="1"/>
          <p:nvPr/>
        </p:nvSpPr>
        <p:spPr>
          <a:xfrm rot="16200000">
            <a:off x="687902" y="3451122"/>
            <a:ext cx="223651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CvsGMF</a:t>
            </a:r>
            <a:endParaRPr 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ABB067B-7874-7853-3C6D-9CB561A1B251}"/>
              </a:ext>
            </a:extLst>
          </p:cNvPr>
          <p:cNvSpPr txBox="1"/>
          <p:nvPr/>
        </p:nvSpPr>
        <p:spPr>
          <a:xfrm rot="16200000">
            <a:off x="726374" y="10166832"/>
            <a:ext cx="21595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CvsGHF</a:t>
            </a:r>
            <a:endParaRPr 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EE1F9D5-CB34-FE5A-78BB-C9E42C7ABAFA}"/>
              </a:ext>
            </a:extLst>
          </p:cNvPr>
          <p:cNvSpPr txBox="1"/>
          <p:nvPr/>
        </p:nvSpPr>
        <p:spPr>
          <a:xfrm>
            <a:off x="447869" y="317241"/>
            <a:ext cx="526106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3236906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1A33EA77-3A3B-C743-2BCC-0104D132BC0B}"/>
              </a:ext>
            </a:extLst>
          </p:cNvPr>
          <p:cNvGrpSpPr/>
          <p:nvPr/>
        </p:nvGrpSpPr>
        <p:grpSpPr>
          <a:xfrm>
            <a:off x="1591342" y="323130"/>
            <a:ext cx="19087379" cy="13984140"/>
            <a:chOff x="825910" y="363097"/>
            <a:chExt cx="19087379" cy="1398414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FC09289-0859-A4C8-4F93-D8D8FE0C4DC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5910" y="363097"/>
              <a:ext cx="10308378" cy="7315834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CAC00C4-3F6A-E7D4-B5E2-34A3D54B5E6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134288" y="363097"/>
              <a:ext cx="8779001" cy="7315834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90AB4D62-DE95-BA1E-9960-03528D7E2BD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5910" y="7767422"/>
              <a:ext cx="10308378" cy="6579815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5C07470-1622-E3C5-0213-A6D41AFA108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134288" y="7678931"/>
              <a:ext cx="8779001" cy="6668306"/>
            </a:xfrm>
            <a:prstGeom prst="rect">
              <a:avLst/>
            </a:prstGeom>
          </p:spPr>
        </p:pic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A9E122AB-A034-6C1D-BDEE-BC7FA3C693E1}"/>
              </a:ext>
            </a:extLst>
          </p:cNvPr>
          <p:cNvSpPr txBox="1"/>
          <p:nvPr/>
        </p:nvSpPr>
        <p:spPr>
          <a:xfrm rot="16200000">
            <a:off x="739198" y="3451122"/>
            <a:ext cx="21339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vsTMF</a:t>
            </a:r>
            <a:endParaRPr 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6AC24B6-9DE1-BB9A-357C-DBB60793801B}"/>
              </a:ext>
            </a:extLst>
          </p:cNvPr>
          <p:cNvSpPr txBox="1"/>
          <p:nvPr/>
        </p:nvSpPr>
        <p:spPr>
          <a:xfrm rot="16200000">
            <a:off x="777670" y="10166832"/>
            <a:ext cx="205697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vsTHF</a:t>
            </a:r>
            <a:endParaRPr 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3123A97-59B4-7504-9F4F-F077BE284852}"/>
              </a:ext>
            </a:extLst>
          </p:cNvPr>
          <p:cNvSpPr txBox="1"/>
          <p:nvPr/>
        </p:nvSpPr>
        <p:spPr>
          <a:xfrm>
            <a:off x="447869" y="317241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426592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5</TotalTime>
  <Words>76</Words>
  <Application>Microsoft Macintosh PowerPoint</Application>
  <PresentationFormat>Personnalisé</PresentationFormat>
  <Paragraphs>10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jad</dc:creator>
  <cp:lastModifiedBy>office</cp:lastModifiedBy>
  <cp:revision>2</cp:revision>
  <dcterms:created xsi:type="dcterms:W3CDTF">2023-08-02T10:31:43Z</dcterms:created>
  <dcterms:modified xsi:type="dcterms:W3CDTF">2023-09-26T14:06:15Z</dcterms:modified>
</cp:coreProperties>
</file>